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6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346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2A1CF-C2BD-4B10-8324-0C925C7218F5}" type="datetimeFigureOut">
              <a:rPr lang="ko-KR" altLang="en-US" smtClean="0"/>
              <a:t>2024-08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88C1C-B7EF-4CDB-A13C-D5494835BF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2266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2A1CF-C2BD-4B10-8324-0C925C7218F5}" type="datetimeFigureOut">
              <a:rPr lang="ko-KR" altLang="en-US" smtClean="0"/>
              <a:t>2024-08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88C1C-B7EF-4CDB-A13C-D5494835BF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9646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2A1CF-C2BD-4B10-8324-0C925C7218F5}" type="datetimeFigureOut">
              <a:rPr lang="ko-KR" altLang="en-US" smtClean="0"/>
              <a:t>2024-08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88C1C-B7EF-4CDB-A13C-D5494835BF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5471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2A1CF-C2BD-4B10-8324-0C925C7218F5}" type="datetimeFigureOut">
              <a:rPr lang="ko-KR" altLang="en-US" smtClean="0"/>
              <a:t>2024-08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88C1C-B7EF-4CDB-A13C-D5494835BF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742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2A1CF-C2BD-4B10-8324-0C925C7218F5}" type="datetimeFigureOut">
              <a:rPr lang="ko-KR" altLang="en-US" smtClean="0"/>
              <a:t>2024-08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88C1C-B7EF-4CDB-A13C-D5494835BF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3904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2A1CF-C2BD-4B10-8324-0C925C7218F5}" type="datetimeFigureOut">
              <a:rPr lang="ko-KR" altLang="en-US" smtClean="0"/>
              <a:t>2024-08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88C1C-B7EF-4CDB-A13C-D5494835BF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1654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2A1CF-C2BD-4B10-8324-0C925C7218F5}" type="datetimeFigureOut">
              <a:rPr lang="ko-KR" altLang="en-US" smtClean="0"/>
              <a:t>2024-08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88C1C-B7EF-4CDB-A13C-D5494835BF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57904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2A1CF-C2BD-4B10-8324-0C925C7218F5}" type="datetimeFigureOut">
              <a:rPr lang="ko-KR" altLang="en-US" smtClean="0"/>
              <a:t>2024-08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88C1C-B7EF-4CDB-A13C-D5494835BF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4703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2A1CF-C2BD-4B10-8324-0C925C7218F5}" type="datetimeFigureOut">
              <a:rPr lang="ko-KR" altLang="en-US" smtClean="0"/>
              <a:t>2024-08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88C1C-B7EF-4CDB-A13C-D5494835BF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8218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2A1CF-C2BD-4B10-8324-0C925C7218F5}" type="datetimeFigureOut">
              <a:rPr lang="ko-KR" altLang="en-US" smtClean="0"/>
              <a:t>2024-08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88C1C-B7EF-4CDB-A13C-D5494835BF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888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2A1CF-C2BD-4B10-8324-0C925C7218F5}" type="datetimeFigureOut">
              <a:rPr lang="ko-KR" altLang="en-US" smtClean="0"/>
              <a:t>2024-08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888C1C-B7EF-4CDB-A13C-D5494835BF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9771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C2A1CF-C2BD-4B10-8324-0C925C7218F5}" type="datetimeFigureOut">
              <a:rPr lang="ko-KR" altLang="en-US" smtClean="0"/>
              <a:t>2024-08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888C1C-B7EF-4CDB-A13C-D5494835BF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2053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그림 17">
            <a:extLst>
              <a:ext uri="{FF2B5EF4-FFF2-40B4-BE49-F238E27FC236}">
                <a16:creationId xmlns:a16="http://schemas.microsoft.com/office/drawing/2014/main" id="{1214CE97-9586-4C59-BE77-05757F741F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9003" y="586201"/>
            <a:ext cx="4758526" cy="504349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121C035-BC97-45C7-979E-64F5DA75C259}"/>
              </a:ext>
            </a:extLst>
          </p:cNvPr>
          <p:cNvSpPr txBox="1"/>
          <p:nvPr/>
        </p:nvSpPr>
        <p:spPr>
          <a:xfrm>
            <a:off x="1375918" y="5910097"/>
            <a:ext cx="595975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kern="100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 Comparative analysis of canonical pathways regulated by the menstrual cycle and endometriosis (EMS). Proliferative control, pCT; proliferative EMS, pEMS; secretory control, sCT; secretory EMS, sEMS.</a:t>
            </a:r>
            <a:endParaRPr lang="ko-KR" altLang="ko-KR" sz="1000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6828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38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joumc</dc:creator>
  <cp:lastModifiedBy>ajoumc</cp:lastModifiedBy>
  <cp:revision>5</cp:revision>
  <dcterms:created xsi:type="dcterms:W3CDTF">2023-09-22T11:14:39Z</dcterms:created>
  <dcterms:modified xsi:type="dcterms:W3CDTF">2024-08-20T07:15:38Z</dcterms:modified>
</cp:coreProperties>
</file>